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5" r:id="rId2"/>
    <p:sldId id="271" r:id="rId3"/>
    <p:sldId id="272" r:id="rId4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38" autoAdjust="0"/>
    <p:restoredTop sz="95220" autoAdjust="0"/>
  </p:normalViewPr>
  <p:slideViewPr>
    <p:cSldViewPr snapToGrid="0" snapToObjects="1">
      <p:cViewPr varScale="1">
        <p:scale>
          <a:sx n="81" d="100"/>
          <a:sy n="81" d="100"/>
        </p:scale>
        <p:origin x="8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EE8357-3D97-4222-A2D1-7A8DEC6CC6F0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BBC190-9F38-4375-97F4-596FF3120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070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BBC190-9F38-4375-97F4-596FF3120C9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4458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BBC190-9F38-4375-97F4-596FF3120C9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2243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5CB10-7F87-D340-AC77-7D2B22A9BD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1136B1-C1C2-5344-9BBE-146F210FD5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090550-843E-C040-92E1-49357E89E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AFE112-24E1-2246-BE0B-E2C0BFB9E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1DA15-3E04-E746-90D4-1C2993004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31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99AAD-3854-D345-BB3B-442385EBD3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420712-31FD-3240-95CF-CF0CE5E74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BCBF52-6E35-B34B-B8B2-A3A76E952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932073-7D5C-7148-A9BA-33075D763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BB184A-DE5F-F34E-A02F-570D7A795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651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121404-5E84-ED4D-A392-1FED258BC8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543F12-71A4-3A48-8B55-6BC7D26CFE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46AB3E-D6BE-D340-8552-9C5D87397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E9D959-7E85-7C4B-9585-AACA56BDE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03BAA3-EAEF-A34C-9A03-7D277268F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522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F117CD-6CE6-274A-88D2-F9E3B106A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EC4607-103E-0148-8B94-F7223AF745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7AE0D3-C180-484B-929E-AA09AA173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091B91-5651-514C-A68D-6E2C987D1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365C5A-2060-454A-AD4E-B5A6E8590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96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7AF1E-A98A-9F45-B495-710885E02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DEFDE3-0220-E948-BECA-007F68B933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C8FC7-C556-FC42-90BF-521AEA98B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9D9D6-46F9-474F-AEC9-508205A28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7C9A0-4D6D-134F-8074-8DDF11A47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953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B1DE4-AB9E-4944-80AE-DAD4828D5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AA8FC7-A649-0743-8E96-70324A3504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ACF2DA-7874-BE44-BEBC-FEB20B4D8D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B64FD-1BD2-6146-8B48-B0D825A93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17170C-178D-C343-AD61-9740B1F10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F78743-4C7B-644B-BCA2-2BEAD9610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989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B8FAB6-9C04-C94B-8454-46EE7B495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5817FE-FFD1-BB4C-A87D-3CCD09BDF0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A67BA2-1D30-7841-A897-4D91B6DA10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FEA671-7BCC-D846-8DA6-A15C055BA5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E21BC2-770D-4F4B-9670-830C9A42D1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923353-20DF-FA43-99E5-A575F9956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16324E-0512-0847-8F78-90357FD1E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00DAC8-D5AA-BF49-9857-59CC53B9A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327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D81C3-5D88-E541-827E-9F3463B9A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DBA4F5-B41F-A546-9822-66B4DC7EE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07E57E-6853-2A45-AABE-96EDB80D1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C314F2-57B9-3B4A-8B3D-DDF9B9544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12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5D4D3A-7CF1-874E-9FCD-D4E8F8BCF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70C03-1FCA-D146-9FDC-1A4F8D75F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C4F469-F9C9-3C4A-B7DF-0B618B5F9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863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3012AC-D874-1C4A-9A13-A162287FC7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C2E34-3CEB-034D-BF25-39F77EA970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7C7124-F55C-C947-AF10-C1B9CF906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06D160-A32A-4E4A-91A9-2FF01E588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C2AEC-8AC5-DC4F-8E88-4752776ED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92402D-A27E-5943-B62B-2F8A58C1E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099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B2B54-E75C-484A-AF3E-0DAA5428DD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BA3985-02E5-B244-BC3A-7963C0F191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55ADA1-0E53-4E4D-9C64-7758E5A233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F0394A-61C7-3F45-8DD3-CCF29A2D9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D5F5B7-AD19-6940-8A86-738367840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06EC07-5D38-7249-B722-CB0D64946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42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BD029F-B276-C14F-8194-D7B44792E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4FE7CB-0BCE-5A41-8E3A-7619C848E9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FA43E0-942F-C049-A46C-CE36C26754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3874EE-BCB3-C248-8E98-76D78A8837F9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FE974-C5BD-A548-99B6-D11564BE3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9BB7D-937C-9A4E-B447-92FE77BC4D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26224-2244-D54B-8632-DE5F60212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123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383339" y="723933"/>
            <a:ext cx="4653609" cy="230832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  <a:cs typeface="Times" panose="02020603050405020304" pitchFamily="18" charset="0"/>
              </a:rPr>
              <a:t>Table S1.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Summary of the serology assays included.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383339" y="3198168"/>
            <a:ext cx="11153340" cy="230832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>
              <a:tabLst>
                <a:tab pos="180975" algn="l"/>
                <a:tab pos="444500" algn="l"/>
              </a:tabLst>
            </a:pP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S – Spike region of the SARS CoV-2 protein; N – </a:t>
            </a:r>
            <a:r>
              <a:rPr lang="en-US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Nucleocapsid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region of the SARS CoV-2 protein; CMIA – 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Chemiluminescent </a:t>
            </a:r>
            <a:r>
              <a:rPr lang="en-IN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microparticle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</a:t>
            </a:r>
            <a:r>
              <a:rPr lang="en-IN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Immunossay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; AU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– 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Arbitrary units</a:t>
            </a:r>
            <a:endParaRPr lang="en-US" sz="900" dirty="0">
              <a:latin typeface="Palatino Linotype" panose="02040502050505030304" pitchFamily="18" charset="0"/>
              <a:cs typeface="Times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7800654"/>
              </p:ext>
            </p:extLst>
          </p:nvPr>
        </p:nvGraphicFramePr>
        <p:xfrm>
          <a:off x="383340" y="1067664"/>
          <a:ext cx="11153340" cy="19934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196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145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605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426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689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824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3868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27220">
                <a:tc rowSpan="2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nstrument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000" b="1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ompany</a:t>
                      </a:r>
                    </a:p>
                    <a:p>
                      <a:pPr algn="ctr"/>
                      <a:endParaRPr lang="en-IN" sz="1000" b="1" dirty="0">
                        <a:latin typeface="Palatino Linotype" panose="0204050205050503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ethodology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arget Antigen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ntibody</a:t>
                      </a:r>
                    </a:p>
                  </a:txBody>
                  <a:tcPr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linical Interpretation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IN" sz="1200" b="1" dirty="0">
                        <a:latin typeface="Times" panose="02020603050405020304" pitchFamily="18" charset="0"/>
                        <a:cs typeface="Times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0292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egative</a:t>
                      </a:r>
                    </a:p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Non-Reactiv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ntermediate</a:t>
                      </a:r>
                    </a:p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Reactiv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Positive</a:t>
                      </a:r>
                    </a:p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Reactiv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rtho Vitros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3600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Vitros Immunodiagnostics</a:t>
                      </a:r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mmunometric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ARS -CoV-2 protein S1 antige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otal antibody (IgG, IgA, and IgM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&lt; 1.0 Inde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Applic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.0 Inde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Dynex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DSX</a:t>
                      </a:r>
                    </a:p>
                  </a:txBody>
                  <a:tcP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nsh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Labs</a:t>
                      </a:r>
                    </a:p>
                  </a:txBody>
                  <a:tcP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ELIS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 and S region of the SARS – CoV-2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&lt;10.0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AU/mL)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0.1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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 12.0 (AU/mL)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&gt; 12.0 (AU/mL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rchitect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i2000SR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bbott Laboratories</a:t>
                      </a:r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MIA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 protein of SARS – CoV-2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&lt; 1.4 Inde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Applic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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.4 Inde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48219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2518639"/>
              </p:ext>
            </p:extLst>
          </p:nvPr>
        </p:nvGraphicFramePr>
        <p:xfrm>
          <a:off x="216569" y="331249"/>
          <a:ext cx="11754854" cy="2809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347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97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284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62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89823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30868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82973">
                <a:tc gridSpan="2"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pecimen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ge</a:t>
                      </a:r>
                      <a:r>
                        <a:rPr lang="en-IN" sz="1000" b="1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years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mean </a:t>
                      </a:r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SD)</a:t>
                      </a:r>
                      <a:endParaRPr lang="en-IN" sz="1000" b="1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ale</a:t>
                      </a:r>
                    </a:p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 (%)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ema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 (%)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 Component</a:t>
                      </a:r>
                    </a:p>
                    <a:p>
                      <a:pPr algn="ctr"/>
                      <a:r>
                        <a:rPr lang="en-IN" sz="1000" b="1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(n %)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1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Hematological</a:t>
                      </a:r>
                      <a:r>
                        <a:rPr lang="en-IN" sz="1000" b="1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Malignancies (HM)</a:t>
                      </a:r>
                    </a:p>
                    <a:p>
                      <a:pPr algn="ctr"/>
                      <a:r>
                        <a:rPr lang="en-IN" sz="1000" b="1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(n %)</a:t>
                      </a:r>
                      <a:endParaRPr lang="en-IN" sz="1000" b="1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M (n=30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5.77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7.23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6 (5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4 (47)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 Kappa (73.33); IgG Lambda (23.33); FLC</a:t>
                      </a: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Lambda (3.33)</a:t>
                      </a:r>
                      <a:endParaRPr lang="en-IN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ultiple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Myeloma (100)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algn="ctr"/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HM + t-</a:t>
                      </a:r>
                      <a:r>
                        <a:rPr lang="en-IN" sz="1000" b="0" baseline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Ab</a:t>
                      </a:r>
                      <a:endParaRPr lang="en-IN" sz="1000" b="0" baseline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  <a:p>
                      <a:pPr algn="ctr"/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n=63)</a:t>
                      </a:r>
                    </a:p>
                    <a:p>
                      <a:pPr algn="ctr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ean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SD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DARA (n=45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8.31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10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.71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20 (44)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25 (56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 Lambda/Kappa</a:t>
                      </a: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2.22); FLC Kappa (2.22); FLC Lambda (8.89); IgA Kappa (6.67); IgA Lambda (2.22); IgG Kappa (53.33); IgG Lambda (17.78); IgG/IgM Lambda (2.22); IgM Lambda (2.22); </a:t>
                      </a:r>
                      <a:r>
                        <a:rPr lang="en-IN" sz="1000" b="0" baseline="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ligoclonal</a:t>
                      </a: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bands (2.22)</a:t>
                      </a:r>
                      <a:endParaRPr lang="en-IN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ultiple Myeloma (100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002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itu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n=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5.91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9.8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 (6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4 (4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M Kappa</a:t>
                      </a: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10); IgG Kappa (10); </a:t>
                      </a: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Diffuse Large B-Cell Lymphoma</a:t>
                      </a: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30); B-Cell Lymphoma (10); AML (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baseline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ollicular Non-Hodgkin’s Lymphoma (10)</a:t>
                      </a:r>
                      <a:endParaRPr lang="en-IN" sz="1000" b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ultiple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Myeloma (20); B Cell Lymphoma (50); AML  (10); </a:t>
                      </a:r>
                      <a:r>
                        <a:rPr lang="en-IN" sz="1000" b="0" baseline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Plasmablastic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Lymphoma (10); Follicular Non-Hodgkin’s Lymphoma (10)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bin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n=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7.4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12.5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4 (8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 (2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LL of B-Cell Type 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(40); CLL (40); Hodgkin’s  (10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Bren (n=3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0.0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  <a:sym typeface="Symbol" panose="05050102010706020507" pitchFamily="18" charset="2"/>
                        </a:rPr>
                        <a:t> </a:t>
                      </a: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6.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 (3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2 (67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b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Cell Lymphoma (33.33); Classical Non-Hodgkin’s Lymphoma (33.33); Mycosis </a:t>
                      </a:r>
                      <a:r>
                        <a:rPr lang="en-IN" sz="1000" b="0" baseline="0" dirty="0" err="1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ungoides</a:t>
                      </a:r>
                      <a:r>
                        <a:rPr lang="en-IN" sz="1000" b="0" baseline="0" dirty="0"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(33.33)</a:t>
                      </a:r>
                      <a:endParaRPr lang="en-IN" sz="1000" b="0" dirty="0"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192438" y="48128"/>
            <a:ext cx="11959459" cy="230832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  <a:cs typeface="Times" panose="02020603050405020304" pitchFamily="18" charset="0"/>
              </a:rPr>
              <a:t>Table S2.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Clinical characteristics of patients included in this study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216569" y="3313584"/>
            <a:ext cx="11754854" cy="230832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>
              <a:tabLst>
                <a:tab pos="180975" algn="l"/>
                <a:tab pos="444500" algn="l"/>
              </a:tabLst>
            </a:pP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t-</a:t>
            </a:r>
            <a:r>
              <a:rPr lang="en-US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mAb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– Therapeutic monoclonal antibody; </a:t>
            </a:r>
            <a:r>
              <a:rPr lang="en-IN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CoV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–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COVID-19; FLC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– Free Light Chain; AML – Acute Myeloid Leukemia; CLL – Chronic Lymphocytic Leukemia</a:t>
            </a:r>
          </a:p>
        </p:txBody>
      </p:sp>
    </p:spTree>
    <p:extLst>
      <p:ext uri="{BB962C8B-B14F-4D97-AF65-F5344CB8AC3E}">
        <p14:creationId xmlns:p14="http://schemas.microsoft.com/office/powerpoint/2010/main" val="336495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192438" y="48128"/>
            <a:ext cx="11959459" cy="230832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  <a:cs typeface="Times" panose="02020603050405020304" pitchFamily="18" charset="0"/>
              </a:rPr>
              <a:t>Table S3.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Clinical characteristics of patients with hematologic malignancies </a:t>
            </a:r>
            <a:r>
              <a:rPr lang="en-US" sz="900" dirty="0">
                <a:solidFill>
                  <a:schemeClr val="tx1">
                    <a:lumMod val="95000"/>
                    <a:lumOff val="5000"/>
                  </a:schemeClr>
                </a:solidFill>
                <a:latin typeface="Palatino Linotype" panose="02040502050505030304" pitchFamily="18" charset="0"/>
                <a:cs typeface="Times" panose="02020603050405020304" pitchFamily="18" charset="0"/>
              </a:rPr>
              <a:t>who were positive for SARS-CoV-2 infection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by PCR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A940991-8F55-420A-8AAF-D5E08539AEDA}"/>
              </a:ext>
            </a:extLst>
          </p:cNvPr>
          <p:cNvSpPr txBox="1"/>
          <p:nvPr/>
        </p:nvSpPr>
        <p:spPr>
          <a:xfrm>
            <a:off x="192438" y="4843234"/>
            <a:ext cx="11157435" cy="646331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>
              <a:tabLst>
                <a:tab pos="180975" algn="l"/>
                <a:tab pos="444500" algn="l"/>
              </a:tabLst>
            </a:pP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MM – Multiple Myeloma; Ph-like ALL – Philadelphia Chromosome-like Acute Lymphoblastic Leukemia; ARDS – Acute Respiratory Distress Syndrome; MODS – Multiple Organ Dysfunction Syndrome; DVT – Deep Vein Thrombosis; LC – Light Chain; R-ISS –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Revised Myeloma International Staging System; </a:t>
            </a:r>
            <a:r>
              <a:rPr lang="en-IN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RVd</a:t>
            </a:r>
            <a:r>
              <a:rPr lang="en-IN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– Lenalidomide, Bortezomib, and Dexamethasone; R-</a:t>
            </a:r>
            <a:r>
              <a:rPr lang="en-US" sz="900" dirty="0" err="1">
                <a:latin typeface="Palatino Linotype" panose="02040502050505030304" pitchFamily="18" charset="0"/>
                <a:cs typeface="Times" panose="02020603050405020304" pitchFamily="18" charset="0"/>
              </a:rPr>
              <a:t>hyperCVAD</a:t>
            </a:r>
            <a:r>
              <a:rPr lang="en-US" sz="900" dirty="0">
                <a:latin typeface="Palatino Linotype" panose="02040502050505030304" pitchFamily="18" charset="0"/>
                <a:cs typeface="Times" panose="02020603050405020304" pitchFamily="18" charset="0"/>
              </a:rPr>
              <a:t> – Chemo-immunotherapy regimen containing Rituximab, Cyclophosphamide, Vincristine, Doxorubicin, Dexamethasone, High-dose Methotrexate, and Cytarabine; Type 2 DM – Type 2 Diabetes Mellitus; COPD – Chronic Obstructive Pulmonary Disorder; COP - Cryptogenic Organizing Pneumonia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26624A8-DE03-454A-B08E-CF30099FEA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624131"/>
              </p:ext>
            </p:extLst>
          </p:nvPr>
        </p:nvGraphicFramePr>
        <p:xfrm>
          <a:off x="192436" y="387290"/>
          <a:ext cx="11157436" cy="4347614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659971">
                  <a:extLst>
                    <a:ext uri="{9D8B030D-6E8A-4147-A177-3AD203B41FA5}">
                      <a16:colId xmlns:a16="http://schemas.microsoft.com/office/drawing/2014/main" val="1049046937"/>
                    </a:ext>
                  </a:extLst>
                </a:gridCol>
                <a:gridCol w="471021">
                  <a:extLst>
                    <a:ext uri="{9D8B030D-6E8A-4147-A177-3AD203B41FA5}">
                      <a16:colId xmlns:a16="http://schemas.microsoft.com/office/drawing/2014/main" val="2540548091"/>
                    </a:ext>
                  </a:extLst>
                </a:gridCol>
                <a:gridCol w="577243">
                  <a:extLst>
                    <a:ext uri="{9D8B030D-6E8A-4147-A177-3AD203B41FA5}">
                      <a16:colId xmlns:a16="http://schemas.microsoft.com/office/drawing/2014/main" val="4005685079"/>
                    </a:ext>
                  </a:extLst>
                </a:gridCol>
                <a:gridCol w="1398949">
                  <a:extLst>
                    <a:ext uri="{9D8B030D-6E8A-4147-A177-3AD203B41FA5}">
                      <a16:colId xmlns:a16="http://schemas.microsoft.com/office/drawing/2014/main" val="674881683"/>
                    </a:ext>
                  </a:extLst>
                </a:gridCol>
                <a:gridCol w="1895893">
                  <a:extLst>
                    <a:ext uri="{9D8B030D-6E8A-4147-A177-3AD203B41FA5}">
                      <a16:colId xmlns:a16="http://schemas.microsoft.com/office/drawing/2014/main" val="2239924687"/>
                    </a:ext>
                  </a:extLst>
                </a:gridCol>
                <a:gridCol w="1526436">
                  <a:extLst>
                    <a:ext uri="{9D8B030D-6E8A-4147-A177-3AD203B41FA5}">
                      <a16:colId xmlns:a16="http://schemas.microsoft.com/office/drawing/2014/main" val="2893301862"/>
                    </a:ext>
                  </a:extLst>
                </a:gridCol>
                <a:gridCol w="1840865">
                  <a:extLst>
                    <a:ext uri="{9D8B030D-6E8A-4147-A177-3AD203B41FA5}">
                      <a16:colId xmlns:a16="http://schemas.microsoft.com/office/drawing/2014/main" val="2444224505"/>
                    </a:ext>
                  </a:extLst>
                </a:gridCol>
                <a:gridCol w="1552147">
                  <a:extLst>
                    <a:ext uri="{9D8B030D-6E8A-4147-A177-3AD203B41FA5}">
                      <a16:colId xmlns:a16="http://schemas.microsoft.com/office/drawing/2014/main" val="1588449854"/>
                    </a:ext>
                  </a:extLst>
                </a:gridCol>
                <a:gridCol w="1234911">
                  <a:extLst>
                    <a:ext uri="{9D8B030D-6E8A-4147-A177-3AD203B41FA5}">
                      <a16:colId xmlns:a16="http://schemas.microsoft.com/office/drawing/2014/main" val="683020118"/>
                    </a:ext>
                  </a:extLst>
                </a:gridCol>
              </a:tblGrid>
              <a:tr h="38539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Patient No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ge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ex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Underlying HM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ngoing HM treatment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ther Comorbidities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OVID-19 course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OVID-19 treatment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b="1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Outcome post COVID-19</a:t>
                      </a:r>
                      <a:endParaRPr lang="en-US" sz="10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7790269"/>
                  </a:ext>
                </a:extLst>
              </a:tr>
              <a:tr h="35232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1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54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lapsed/Refractory Ph-like ALL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-</a:t>
                      </a:r>
                      <a:r>
                        <a:rPr lang="en-IN" sz="1000" dirty="0" err="1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hyperCVAD</a:t>
                      </a: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 plus </a:t>
                      </a:r>
                      <a:r>
                        <a:rPr lang="en-IN" sz="1000" dirty="0" err="1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uxolitinib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2 DM, hypertension, morbid obesity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omplicated by ARDS, MODS, DVT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 err="1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mdesivir</a:t>
                      </a: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, steroids mechanical ventilat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Expi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1215406780"/>
                  </a:ext>
                </a:extLst>
              </a:tr>
              <a:tr h="4571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9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 kappa MM,     R-ISS stage I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Vd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2 DM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ransaminitis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upportive car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2996356942"/>
                  </a:ext>
                </a:extLst>
              </a:tr>
              <a:tr h="50904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3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8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Kappa LC MM,     R-ISS stage I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 err="1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xazomib</a:t>
                      </a: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, lenalidomide, dexamethason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2 DM, hypertens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Complicated by hypoxia, GI side effects of nausea and vomiting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upplemental Oxygen, steroids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119209302"/>
                  </a:ext>
                </a:extLst>
              </a:tr>
              <a:tr h="65987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4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71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F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 lambda MM,   R-ISS stage I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Vd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ne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Asymptomatic, Screening PCR 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upportive car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3991671585"/>
                  </a:ext>
                </a:extLst>
              </a:tr>
              <a:tr h="4441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5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55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G kappa MM,     R-ISS stage I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Lenalidomide maintenance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2 DM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needing hospitalization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upportive car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761924766"/>
                  </a:ext>
                </a:extLst>
              </a:tr>
              <a:tr h="4807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64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M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IgA lambda MM,   R-ISS stage 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on active therapy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Type 2 DM, hypertens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needing hospitalizat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Supportive car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extLst>
                  <a:ext uri="{0D108BD9-81ED-4DB2-BD59-A6C34878D82A}">
                    <a16:rowId xmlns:a16="http://schemas.microsoft.com/office/drawing/2014/main" val="3993414518"/>
                  </a:ext>
                </a:extLst>
              </a:tr>
              <a:tr h="190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7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69</a:t>
                      </a: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M</a:t>
                      </a: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tle cell lymphoma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tus post autologous stem cell transplant 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PD, hypertens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plicated by bilateral pleural effusions, COP, pulmonary hypertens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 err="1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mdesivir</a:t>
                      </a: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dexamethasone, supplemental oxyge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76521994"/>
                  </a:ext>
                </a:extLst>
              </a:tr>
              <a:tr h="44665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8</a:t>
                      </a:r>
                    </a:p>
                  </a:txBody>
                  <a:tcPr marL="41027" marR="4102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50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M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IgA kappa MM, R-ISS stage II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Daratumumab, carfilzomib, dexamethasone maintenanc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Non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000" dirty="0">
                        <a:effectLst/>
                        <a:latin typeface="Palatino Linotype" panose="02040502050505030304" pitchFamily="18" charset="0"/>
                        <a:cs typeface="Times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cs typeface="Times" panose="02020603050405020304" pitchFamily="18" charset="0"/>
                        </a:rPr>
                        <a:t>Not needing hospitalizatio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Supplemental oxygen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ecovered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670110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9217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23</TotalTime>
  <Words>829</Words>
  <Application>Microsoft Office PowerPoint</Application>
  <PresentationFormat>Widescreen</PresentationFormat>
  <Paragraphs>17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 SoRelle</dc:creator>
  <cp:lastModifiedBy>Madhusudhanan Narasimhan</cp:lastModifiedBy>
  <cp:revision>258</cp:revision>
  <cp:lastPrinted>2020-10-28T22:46:48Z</cp:lastPrinted>
  <dcterms:created xsi:type="dcterms:W3CDTF">2020-05-02T16:33:06Z</dcterms:created>
  <dcterms:modified xsi:type="dcterms:W3CDTF">2020-11-19T18:28:10Z</dcterms:modified>
</cp:coreProperties>
</file>